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Improvement by 1 or more points</c:v>
                </c:pt>
                <c:pt idx="1">
                  <c:v>Improvement by 2 or more points</c:v>
                </c:pt>
                <c:pt idx="2">
                  <c:v>Improvement by 3 or more points</c:v>
                </c:pt>
                <c:pt idx="3">
                  <c:v>Improvement by 4 or more points</c:v>
                </c:pt>
                <c:pt idx="4">
                  <c:v>5 point improvement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86.7</c:v>
                </c:pt>
                <c:pt idx="1">
                  <c:v>85.3</c:v>
                </c:pt>
                <c:pt idx="2">
                  <c:v>44</c:v>
                </c:pt>
                <c:pt idx="3">
                  <c:v>37.6</c:v>
                </c:pt>
                <c:pt idx="4">
                  <c:v>1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4F-4D47-8424-E3C968A14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4"/>
        <c:overlap val="-27"/>
        <c:axId val="68872048"/>
        <c:axId val="68883696"/>
      </c:barChart>
      <c:catAx>
        <c:axId val="68872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83696"/>
        <c:crosses val="autoZero"/>
        <c:auto val="1"/>
        <c:lblAlgn val="ctr"/>
        <c:lblOffset val="100"/>
        <c:noMultiLvlLbl val="0"/>
      </c:catAx>
      <c:valAx>
        <c:axId val="68883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72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eries 1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4</c:f>
              <c:strCache>
                <c:ptCount val="3"/>
                <c:pt idx="0">
                  <c:v>Worsening by 1 or more points</c:v>
                </c:pt>
                <c:pt idx="1">
                  <c:v>Worsening by 2 or more points</c:v>
                </c:pt>
                <c:pt idx="2">
                  <c:v>Worsening by 3 points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8.67</c:v>
                </c:pt>
                <c:pt idx="1">
                  <c:v>6.67</c:v>
                </c:pt>
                <c:pt idx="2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4F-4D47-8424-E3C968A14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0"/>
        <c:overlap val="-27"/>
        <c:axId val="68872048"/>
        <c:axId val="68883696"/>
      </c:barChart>
      <c:catAx>
        <c:axId val="68872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83696"/>
        <c:crosses val="autoZero"/>
        <c:auto val="1"/>
        <c:lblAlgn val="ctr"/>
        <c:lblOffset val="100"/>
        <c:noMultiLvlLbl val="0"/>
      </c:catAx>
      <c:valAx>
        <c:axId val="6888369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872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C4CCC-439B-4798-81A8-9337768FEE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ADADD4-9FFF-4601-A56B-1292DC6EC9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567416-2809-4885-853B-E7C9F0929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09243-821A-42A6-875D-EE72AA94B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A50964-6271-49E3-B221-4FD48EFC7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2431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84361-B9C0-49E4-BADE-BECA5386E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0E1E2D-E1BC-4B8B-959E-94EFCE8D07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477EA2-B6B8-46EB-9F61-122287C8C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A0A405-55B3-4354-A9CA-4DF9C571C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2F35B7-CAB7-464D-9A58-135FB6EA2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6268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A32B9C-B03D-4D32-B9D5-65B584FA0D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FC08C-53C8-4778-8303-9CF5457A37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506C6-187A-4647-B6E6-5317DACF3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CE1DFD-8D0A-4772-8DBC-2B5D0F188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423DA-86D3-43FF-AFAD-7A42052BA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4965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BF9A22-C91D-421C-A8E4-13C999BEE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7E0FB4-9246-4111-A904-699260467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72CCE1-BC18-4D0C-84D2-FA19A53FA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DE557-2230-4EB7-AD62-3E773D684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EDB13F-EF07-42FA-8AD5-60D6A63A1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7268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A9D308-956B-40A8-A8F2-89DDE098E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7F19B-3987-4E49-9F75-98F41ECC7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2617FB-BA81-415A-9F20-E1A498087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9B28CE-719C-4D1B-A52D-EC9987E3E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B03A76-50E6-40D4-8DEE-9E38884B9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40822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4DC61-8E60-4582-8907-C12056B863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965B3F-7E02-452E-884A-E15BBD5077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20492D-2843-495A-B3A6-7043E4B8FB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644F00-8B5A-42CE-9FE4-5543F9F4A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91BDF8-F49E-4BD6-A43C-11D1F5A1E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E59DB5-E36D-47F2-BAFC-B83F7616A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711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C8D48B-651C-41DD-884A-7CCA93F04B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889738-C453-48B1-BCEF-26C8786A05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FE88B6-E73C-4FF4-8411-D515AFDF47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6B8040-03E0-43D0-9329-A0FE2F8133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5E2F27-14BD-4B7C-8FBD-D59DB9AEBB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0F92D0-3BEF-4B56-B3D8-C5F562484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586190-63BB-4EEE-AF70-DDEE2FBDA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B034C8-8D12-488B-A8AA-F3284FEBD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1642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95475-461E-4FBB-80A6-4ED55DBD9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C9A140-5BB2-4AC5-9CD1-0B8CFF998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F55A7D-D2CB-48EC-B841-19E675471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174B329-7DB2-499B-9FF4-BE4A85361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3504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46110A-22BB-4641-A6F0-641095AB0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909BCE-3916-4948-8775-7AA21F934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2A427A-2D79-4108-8717-1A19CE7CB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9273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D7332-2567-4531-866D-118679F3EF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7AB945-D504-42BD-9569-B390038328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29B594-02B3-491B-A593-8BAB99A3CF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4BBC28-9090-4C03-B7C2-4319DD57F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AE423-87FA-4821-A814-16F0DBA35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4C23AB-3803-4D3A-B1B7-ED0676185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7298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02627-71A6-49E8-BF65-1848F7E166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6601726-35F8-4ECE-BB27-1A7CE1AD87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3117EE-9AC3-4393-8E5E-6DABD97BBD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84EF20-324A-49EA-89AC-5266E4590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4E6238-D0D6-4112-B0DD-7D0DD8B66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AECA49-860A-470B-8FB2-870E6B077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0861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3DCD69-71D2-4EAE-93E7-2572FED3D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BA933F-901F-43E7-834A-C681B90C17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9F3090-FB66-4683-93B5-B037ACCB1C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DB190-F8AF-419D-AD37-2EC4481D7882}" type="datetimeFigureOut">
              <a:rPr lang="en-IN" smtClean="0"/>
              <a:t>25/10/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5C1E86-84B5-4D0D-A82F-776AE0E6D8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1AAA2-EA6A-4FF4-9E6A-F1F61FE1BC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F39A4-4457-487E-A54F-529BDF2AED9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7666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21ABB46-55D4-48B9-8124-F6F10215D392}"/>
              </a:ext>
            </a:extLst>
          </p:cNvPr>
          <p:cNvGrpSpPr/>
          <p:nvPr/>
        </p:nvGrpSpPr>
        <p:grpSpPr>
          <a:xfrm>
            <a:off x="1684656" y="719666"/>
            <a:ext cx="9440544" cy="5418667"/>
            <a:chOff x="1684656" y="719666"/>
            <a:chExt cx="9440544" cy="5418667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3058C95E-9A34-47F9-BFAA-072117ADC5A1}"/>
                </a:ext>
              </a:extLst>
            </p:cNvPr>
            <p:cNvGraphicFramePr/>
            <p:nvPr/>
          </p:nvGraphicFramePr>
          <p:xfrm>
            <a:off x="2032000" y="719666"/>
            <a:ext cx="9093200" cy="54186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7A3B6E9-FEFC-4D77-8149-5D2AFC118FEA}"/>
                </a:ext>
              </a:extLst>
            </p:cNvPr>
            <p:cNvSpPr txBox="1"/>
            <p:nvPr/>
          </p:nvSpPr>
          <p:spPr>
            <a:xfrm>
              <a:off x="1684656" y="1128394"/>
              <a:ext cx="492443" cy="427672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ercentage (%) improvement at Day 30</a:t>
              </a:r>
              <a:endParaRPr kumimoji="0" lang="en-I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D83C6C1-936C-4CE7-A109-0115A294F861}"/>
              </a:ext>
            </a:extLst>
          </p:cNvPr>
          <p:cNvSpPr txBox="1"/>
          <p:nvPr/>
        </p:nvSpPr>
        <p:spPr>
          <a:xfrm>
            <a:off x="1704975" y="304800"/>
            <a:ext cx="5607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  <a:endParaRPr kumimoji="0" lang="en-IN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05776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83D35BD-A5DD-45F4-8C66-501EA6C86F8D}"/>
              </a:ext>
            </a:extLst>
          </p:cNvPr>
          <p:cNvGrpSpPr/>
          <p:nvPr/>
        </p:nvGrpSpPr>
        <p:grpSpPr>
          <a:xfrm>
            <a:off x="1684656" y="719666"/>
            <a:ext cx="9440544" cy="5418667"/>
            <a:chOff x="1684656" y="719666"/>
            <a:chExt cx="9440544" cy="5418667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3058C95E-9A34-47F9-BFAA-072117ADC5A1}"/>
                </a:ext>
              </a:extLst>
            </p:cNvPr>
            <p:cNvGraphicFramePr/>
            <p:nvPr/>
          </p:nvGraphicFramePr>
          <p:xfrm>
            <a:off x="2032000" y="719666"/>
            <a:ext cx="9093200" cy="54186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7A3B6E9-FEFC-4D77-8149-5D2AFC118FEA}"/>
                </a:ext>
              </a:extLst>
            </p:cNvPr>
            <p:cNvSpPr txBox="1"/>
            <p:nvPr/>
          </p:nvSpPr>
          <p:spPr>
            <a:xfrm>
              <a:off x="1684656" y="1128394"/>
              <a:ext cx="492443" cy="427672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ercentage (%) worsening at Day 30</a:t>
              </a:r>
              <a:endParaRPr kumimoji="0" lang="en-I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8A8D70E-C6E0-4D61-A752-C29EC414D529}"/>
              </a:ext>
            </a:extLst>
          </p:cNvPr>
          <p:cNvSpPr txBox="1"/>
          <p:nvPr/>
        </p:nvSpPr>
        <p:spPr>
          <a:xfrm>
            <a:off x="1704975" y="304800"/>
            <a:ext cx="5607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  <a:endParaRPr kumimoji="0" lang="en-IN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82266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ETANJALI TONPE</dc:creator>
  <cp:lastModifiedBy>GEETANJALI TONPE</cp:lastModifiedBy>
  <cp:revision>1</cp:revision>
  <dcterms:created xsi:type="dcterms:W3CDTF">2021-10-25T12:58:43Z</dcterms:created>
  <dcterms:modified xsi:type="dcterms:W3CDTF">2021-10-25T12:59:04Z</dcterms:modified>
</cp:coreProperties>
</file>